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38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AE26E3-A303-48CD-BFAF-AB02BDC0FE6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74AA55E-0A1E-4CDE-9F71-21CE866BFEA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5D78BEB-BC5C-4263-A1E1-7BE47AA06E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81D99-BB7E-4FEA-AE88-DFB657ABEBDA}" type="datetimeFigureOut">
              <a:rPr lang="en-CA" smtClean="0"/>
              <a:t>2019-10-3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9B52F22-F26D-4F72-A03F-B448A6C40E2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85090BB-B896-48D1-AEF4-0FE7BCC97E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487C5-E926-4C00-859B-089975A88D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7690654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ECFDC00-1C5A-4E09-A5D3-CBB16E00EE8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23A6BF80-BF33-4893-8E58-DBAC07CC656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8E133AB-EF1A-4AE6-ACC9-BC120FF89A9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81D99-BB7E-4FEA-AE88-DFB657ABEBDA}" type="datetimeFigureOut">
              <a:rPr lang="en-CA" smtClean="0"/>
              <a:t>2019-10-3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7D4B0D2-733B-4807-9D75-1F1BCF4F07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7416373-8EA6-4389-AE90-745AAEBF1C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487C5-E926-4C00-859B-089975A88D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561579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0CC71002-4BC5-4D08-91DF-AE16905648F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895ADA12-112C-4CFD-BEFC-12F626F96254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1F36553-1852-4E35-A1FE-3D60395156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81D99-BB7E-4FEA-AE88-DFB657ABEBDA}" type="datetimeFigureOut">
              <a:rPr lang="en-CA" smtClean="0"/>
              <a:t>2019-10-3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281FCCA-04DE-4151-8AF5-B0149B6606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83A4496-42AB-4E74-95C4-6CD056650F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487C5-E926-4C00-859B-089975A88D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73200340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ADA3C1-CDA1-43EE-AC1C-6AD3BC522A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15A0FCE1-EADC-4864-BD3F-59F44FB5588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72C2A4-F23C-4998-A38C-A365EE4255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81D99-BB7E-4FEA-AE88-DFB657ABEBDA}" type="datetimeFigureOut">
              <a:rPr lang="en-CA" smtClean="0"/>
              <a:t>2019-10-3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C3C9C3B-91CC-42C4-83ED-69A6505EEB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D2192C-EA89-45F3-9A87-4C10E73ECBD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487C5-E926-4C00-859B-089975A88D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94403279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8B6B771-4E09-40D5-8CCC-00528AC2E87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F470A9D2-8B0F-404F-B256-D0E401F90A0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DF60F3D-A6BE-4D70-BF2C-EF5AC7A71D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81D99-BB7E-4FEA-AE88-DFB657ABEBDA}" type="datetimeFigureOut">
              <a:rPr lang="en-CA" smtClean="0"/>
              <a:t>2019-10-3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EC14226-0095-4AA6-8289-98061DEA338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CF29C4-A70B-480E-952F-C610D169554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487C5-E926-4C00-859B-089975A88D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71658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F4E796-4955-48CA-B53E-6B290B2EA6A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F27831F-8AAF-4C68-9793-6EF370C9026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8D9B7D2-46B8-48FD-8D70-F9CE7F9A990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2C03C4D-2C8B-4034-BA1F-1E42F47AD6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81D99-BB7E-4FEA-AE88-DFB657ABEBDA}" type="datetimeFigureOut">
              <a:rPr lang="en-CA" smtClean="0"/>
              <a:t>2019-10-3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546F253-42CE-40C3-9715-AB0A0818C2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26CA2DC-A284-40CF-9D0B-FE085BAEFAC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487C5-E926-4C00-859B-089975A88D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310591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6F5E27D-EC32-4F3E-8D62-B508C6D986A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D921267-FA16-4D96-A8C6-6CDE7FC9038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1819E1B-E16C-47AC-91C3-31E39116D2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4CCD44F2-2B44-49D4-B327-E53E6F02464D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338AA438-DDBD-4D90-9C79-8EBD87BC0BBE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8C722F6-9980-4A09-BBE7-0DC57814BEC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81D99-BB7E-4FEA-AE88-DFB657ABEBDA}" type="datetimeFigureOut">
              <a:rPr lang="en-CA" smtClean="0"/>
              <a:t>2019-10-31</a:t>
            </a:fld>
            <a:endParaRPr lang="en-CA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79F4289-35BE-463A-8587-EA69C463EC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29587E2-B0AA-486B-AE4C-790DE2723BD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487C5-E926-4C00-859B-089975A88D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23278423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47C836-B623-4ED2-A90E-5D4BBEB124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5CDA8B2A-5E52-4F18-8F61-6C8CBD08937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81D99-BB7E-4FEA-AE88-DFB657ABEBDA}" type="datetimeFigureOut">
              <a:rPr lang="en-CA" smtClean="0"/>
              <a:t>2019-10-31</a:t>
            </a:fld>
            <a:endParaRPr lang="en-CA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BAAA8964-455C-4DBA-AA12-2E1835BA9C7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1F2C5B2-8C05-4D7D-89B0-22A076B174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487C5-E926-4C00-859B-089975A88D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4244596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AB3D5EED-6EC5-40F0-9BEE-1CE26CB86F5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81D99-BB7E-4FEA-AE88-DFB657ABEBDA}" type="datetimeFigureOut">
              <a:rPr lang="en-CA" smtClean="0"/>
              <a:t>2019-10-31</a:t>
            </a:fld>
            <a:endParaRPr lang="en-CA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A30E8615-4636-4D38-8B4D-12441BBFF08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62F6071-3019-40A1-94F4-ADA13514B1D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487C5-E926-4C00-859B-089975A88D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574940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F6439A2-F06D-4FCB-852E-89C70A03F82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CFDA064-17AD-4A16-B4C3-03534A9FEA7D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6EEB1F68-8E5D-48B6-B8A4-5FE6334834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7CD6F7B-7B4F-45B8-8BFC-59DD7330118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81D99-BB7E-4FEA-AE88-DFB657ABEBDA}" type="datetimeFigureOut">
              <a:rPr lang="en-CA" smtClean="0"/>
              <a:t>2019-10-3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65BF59E2-93BB-45C2-BFF5-FA7F795FB9B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7B7F1820-224B-411D-9E90-1A64549142C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487C5-E926-4C00-859B-089975A88D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0101810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7354538-A9CA-4592-8EF3-BF81FA28011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BEE8DBD-58BA-4E42-ABC5-0F4ADBEB8B2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CA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912241B-BD92-4441-826A-340F1C9564D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9900A0E-EC96-413A-BF90-B78155CF04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581D99-BB7E-4FEA-AE88-DFB657ABEBDA}" type="datetimeFigureOut">
              <a:rPr lang="en-CA" smtClean="0"/>
              <a:t>2019-10-31</a:t>
            </a:fld>
            <a:endParaRPr lang="en-CA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C56A26CF-7B06-4FDD-B952-3E02F566A7F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CA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967ADD8-88FD-44E5-B999-BE6EF2A70A6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FB487C5-E926-4C00-859B-089975A88D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180318577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D5B80240-E189-4CD5-99FC-7E2C3756771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CA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31B3867-BE33-45E5-AA50-541AAF7B941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CA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F42517-08C7-43C9-BE71-9E3AD491C713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581D99-BB7E-4FEA-AE88-DFB657ABEBDA}" type="datetimeFigureOut">
              <a:rPr lang="en-CA" smtClean="0"/>
              <a:t>2019-10-31</a:t>
            </a:fld>
            <a:endParaRPr lang="en-CA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FDF52F4-17F0-4A60-8AE5-DFF520D1B604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CA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738FE9C-3DE1-4D69-A4F8-D43F9445000E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FB487C5-E926-4C00-859B-089975A88D67}" type="slidenum">
              <a:rPr lang="en-CA" smtClean="0"/>
              <a:t>‹#›</a:t>
            </a:fld>
            <a:endParaRPr lang="en-CA"/>
          </a:p>
        </p:txBody>
      </p:sp>
    </p:spTree>
    <p:extLst>
      <p:ext uri="{BB962C8B-B14F-4D97-AF65-F5344CB8AC3E}">
        <p14:creationId xmlns:p14="http://schemas.microsoft.com/office/powerpoint/2010/main" val="31292271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jp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A picture containing computer, sitting, black, table&#10;&#10;Description automatically generated">
            <a:extLst>
              <a:ext uri="{FF2B5EF4-FFF2-40B4-BE49-F238E27FC236}">
                <a16:creationId xmlns:a16="http://schemas.microsoft.com/office/drawing/2014/main" id="{B50C033C-71DA-4790-996E-1BA1FCFD718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982990" y="1423814"/>
            <a:ext cx="6226019" cy="4651267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880A5AE-802B-4F72-944A-E91A6403704A}"/>
              </a:ext>
            </a:extLst>
          </p:cNvPr>
          <p:cNvSpPr txBox="1"/>
          <p:nvPr/>
        </p:nvSpPr>
        <p:spPr>
          <a:xfrm>
            <a:off x="3377681" y="419878"/>
            <a:ext cx="6456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CA" b="1" dirty="0"/>
              <a:t>Supplementary Information File 1 – Uncropped </a:t>
            </a:r>
            <a:r>
              <a:rPr lang="en-CA" b="1" dirty="0" err="1"/>
              <a:t>ProQ</a:t>
            </a:r>
            <a:r>
              <a:rPr lang="en-CA" b="1" dirty="0"/>
              <a:t> Gels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850C6509-5AEE-4858-BC03-D3F5ABB111E7}"/>
              </a:ext>
            </a:extLst>
          </p:cNvPr>
          <p:cNvSpPr txBox="1"/>
          <p:nvPr/>
        </p:nvSpPr>
        <p:spPr>
          <a:xfrm>
            <a:off x="3456808" y="962147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Middle-aged</a:t>
            </a:r>
          </a:p>
          <a:p>
            <a:pPr algn="ctr"/>
            <a:r>
              <a:rPr lang="en-CA" sz="1200" dirty="0"/>
              <a:t> male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5C7A44F-26B5-4FC2-A39F-7DDC35E842AC}"/>
              </a:ext>
            </a:extLst>
          </p:cNvPr>
          <p:cNvSpPr txBox="1"/>
          <p:nvPr/>
        </p:nvSpPr>
        <p:spPr>
          <a:xfrm>
            <a:off x="3456808" y="6075080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Older</a:t>
            </a:r>
          </a:p>
          <a:p>
            <a:pPr algn="ctr"/>
            <a:r>
              <a:rPr lang="en-CA" sz="1200" dirty="0"/>
              <a:t> mal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458935B0-1425-4210-ACD4-9784FA0112E6}"/>
              </a:ext>
            </a:extLst>
          </p:cNvPr>
          <p:cNvSpPr txBox="1"/>
          <p:nvPr/>
        </p:nvSpPr>
        <p:spPr>
          <a:xfrm>
            <a:off x="4637244" y="962147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Unrelated projec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A9773050-CDC1-4F2F-8AC2-AC4BA1899E6E}"/>
              </a:ext>
            </a:extLst>
          </p:cNvPr>
          <p:cNvSpPr txBox="1"/>
          <p:nvPr/>
        </p:nvSpPr>
        <p:spPr>
          <a:xfrm>
            <a:off x="7578757" y="962147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Unrelated project</a:t>
            </a:r>
          </a:p>
        </p:txBody>
      </p:sp>
      <p:pic>
        <p:nvPicPr>
          <p:cNvPr id="14" name="Picture 13">
            <a:extLst>
              <a:ext uri="{FF2B5EF4-FFF2-40B4-BE49-F238E27FC236}">
                <a16:creationId xmlns:a16="http://schemas.microsoft.com/office/drawing/2014/main" id="{5F8D8DCE-4189-405E-B5D5-013FCDA4DC07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44264" y="3172946"/>
            <a:ext cx="1103472" cy="512108"/>
          </a:xfrm>
          <a:prstGeom prst="rect">
            <a:avLst/>
          </a:prstGeom>
        </p:spPr>
      </p:pic>
      <p:sp>
        <p:nvSpPr>
          <p:cNvPr id="17" name="TextBox 16">
            <a:extLst>
              <a:ext uri="{FF2B5EF4-FFF2-40B4-BE49-F238E27FC236}">
                <a16:creationId xmlns:a16="http://schemas.microsoft.com/office/drawing/2014/main" id="{199EA155-182E-4986-AFE6-D089BE97CFD6}"/>
              </a:ext>
            </a:extLst>
          </p:cNvPr>
          <p:cNvSpPr txBox="1"/>
          <p:nvPr/>
        </p:nvSpPr>
        <p:spPr>
          <a:xfrm>
            <a:off x="6431949" y="962147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Middle-aged</a:t>
            </a:r>
          </a:p>
          <a:p>
            <a:pPr algn="ctr"/>
            <a:r>
              <a:rPr lang="en-CA" sz="1200" dirty="0"/>
              <a:t> male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C9ADE6B-8698-4D8C-B0CC-ABF583C90BB9}"/>
              </a:ext>
            </a:extLst>
          </p:cNvPr>
          <p:cNvSpPr txBox="1"/>
          <p:nvPr/>
        </p:nvSpPr>
        <p:spPr>
          <a:xfrm>
            <a:off x="6431949" y="6075080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Older</a:t>
            </a:r>
          </a:p>
          <a:p>
            <a:pPr algn="ctr"/>
            <a:r>
              <a:rPr lang="en-CA" sz="1200" dirty="0"/>
              <a:t> female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1CA71907-C3F0-4F7D-B299-BEBB2A12E351}"/>
              </a:ext>
            </a:extLst>
          </p:cNvPr>
          <p:cNvSpPr txBox="1"/>
          <p:nvPr/>
        </p:nvSpPr>
        <p:spPr>
          <a:xfrm>
            <a:off x="7578757" y="6075080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Unrelated project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06BB3529-529C-44E8-B94C-E3EECA9934B9}"/>
              </a:ext>
            </a:extLst>
          </p:cNvPr>
          <p:cNvSpPr txBox="1"/>
          <p:nvPr/>
        </p:nvSpPr>
        <p:spPr>
          <a:xfrm>
            <a:off x="4637244" y="6075080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Unrelated project</a:t>
            </a:r>
          </a:p>
        </p:txBody>
      </p:sp>
    </p:spTree>
    <p:extLst>
      <p:ext uri="{BB962C8B-B14F-4D97-AF65-F5344CB8AC3E}">
        <p14:creationId xmlns:p14="http://schemas.microsoft.com/office/powerpoint/2010/main" val="412102316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white, black, water, standing&#10;&#10;Description automatically generated">
            <a:extLst>
              <a:ext uri="{FF2B5EF4-FFF2-40B4-BE49-F238E27FC236}">
                <a16:creationId xmlns:a16="http://schemas.microsoft.com/office/drawing/2014/main" id="{C640D7D9-3E60-4EC3-9497-ABDCD77D4F6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2823" y="1420617"/>
            <a:ext cx="5781914" cy="4320000"/>
          </a:xfrm>
          <a:prstGeom prst="rect">
            <a:avLst/>
          </a:prstGeom>
        </p:spPr>
      </p:pic>
      <p:sp>
        <p:nvSpPr>
          <p:cNvPr id="5" name="TextBox 5">
            <a:extLst>
              <a:ext uri="{FF2B5EF4-FFF2-40B4-BE49-F238E27FC236}">
                <a16:creationId xmlns:a16="http://schemas.microsoft.com/office/drawing/2014/main" id="{0880A5AE-802B-4F72-944A-E91A6403704A}"/>
              </a:ext>
            </a:extLst>
          </p:cNvPr>
          <p:cNvSpPr txBox="1"/>
          <p:nvPr/>
        </p:nvSpPr>
        <p:spPr>
          <a:xfrm>
            <a:off x="3035388" y="366653"/>
            <a:ext cx="6456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CA" b="1" dirty="0"/>
              <a:t>Supplementary Information File 2 – Uncropped Coomassie Gel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EDAA3ED-0CDA-4047-82BF-83AEDBBD3F22}"/>
              </a:ext>
            </a:extLst>
          </p:cNvPr>
          <p:cNvSpPr txBox="1"/>
          <p:nvPr/>
        </p:nvSpPr>
        <p:spPr>
          <a:xfrm>
            <a:off x="4951003" y="931102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Middle-aged</a:t>
            </a:r>
          </a:p>
          <a:p>
            <a:pPr algn="ctr"/>
            <a:r>
              <a:rPr lang="en-CA" sz="1200" dirty="0"/>
              <a:t> male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32CD1381-34DB-4DD6-B99C-8221623CCA24}"/>
              </a:ext>
            </a:extLst>
          </p:cNvPr>
          <p:cNvSpPr txBox="1"/>
          <p:nvPr/>
        </p:nvSpPr>
        <p:spPr>
          <a:xfrm>
            <a:off x="6300860" y="931102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Unrelated project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93CBAEDB-0C74-4970-B1D5-626542B687BA}"/>
              </a:ext>
            </a:extLst>
          </p:cNvPr>
          <p:cNvSpPr txBox="1"/>
          <p:nvPr/>
        </p:nvSpPr>
        <p:spPr>
          <a:xfrm>
            <a:off x="6300860" y="5716487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Unrelated project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CC62929B-F3C8-4B96-A0E4-3CDAB339DF6C}"/>
              </a:ext>
            </a:extLst>
          </p:cNvPr>
          <p:cNvSpPr txBox="1"/>
          <p:nvPr/>
        </p:nvSpPr>
        <p:spPr>
          <a:xfrm>
            <a:off x="4951003" y="5716487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Old </a:t>
            </a:r>
          </a:p>
          <a:p>
            <a:pPr algn="ctr"/>
            <a:r>
              <a:rPr lang="en-CA" sz="1200" dirty="0"/>
              <a:t> male</a:t>
            </a:r>
          </a:p>
        </p:txBody>
      </p:sp>
    </p:spTree>
    <p:extLst>
      <p:ext uri="{BB962C8B-B14F-4D97-AF65-F5344CB8AC3E}">
        <p14:creationId xmlns:p14="http://schemas.microsoft.com/office/powerpoint/2010/main" val="5211845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 descr="A picture containing indoor, white, sitting, refrigerator&#10;&#10;Description automatically generated">
            <a:extLst>
              <a:ext uri="{FF2B5EF4-FFF2-40B4-BE49-F238E27FC236}">
                <a16:creationId xmlns:a16="http://schemas.microsoft.com/office/drawing/2014/main" id="{AA3FBC18-5926-4D95-98B7-EF623B6686B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280223" y="1393835"/>
            <a:ext cx="5782217" cy="4320000"/>
          </a:xfrm>
          <a:prstGeom prst="rect">
            <a:avLst/>
          </a:prstGeom>
        </p:spPr>
      </p:pic>
      <p:sp>
        <p:nvSpPr>
          <p:cNvPr id="5" name="TextBox 5">
            <a:extLst>
              <a:ext uri="{FF2B5EF4-FFF2-40B4-BE49-F238E27FC236}">
                <a16:creationId xmlns:a16="http://schemas.microsoft.com/office/drawing/2014/main" id="{0880A5AE-802B-4F72-944A-E91A6403704A}"/>
              </a:ext>
            </a:extLst>
          </p:cNvPr>
          <p:cNvSpPr txBox="1"/>
          <p:nvPr/>
        </p:nvSpPr>
        <p:spPr>
          <a:xfrm>
            <a:off x="3102941" y="393832"/>
            <a:ext cx="6456783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CA" b="1" dirty="0"/>
              <a:t>Supplementary Information File 3 – Uncropped Coomassie Gels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4D590B5-E90E-4CBD-A980-27AA2BB65BE5}"/>
              </a:ext>
            </a:extLst>
          </p:cNvPr>
          <p:cNvSpPr txBox="1"/>
          <p:nvPr/>
        </p:nvSpPr>
        <p:spPr>
          <a:xfrm>
            <a:off x="4951003" y="931102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Old</a:t>
            </a:r>
          </a:p>
          <a:p>
            <a:pPr algn="ctr"/>
            <a:r>
              <a:rPr lang="en-CA" sz="1200" dirty="0"/>
              <a:t> female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55D168C-C04F-4B73-A16C-DBCF88A49E4F}"/>
              </a:ext>
            </a:extLst>
          </p:cNvPr>
          <p:cNvSpPr txBox="1"/>
          <p:nvPr/>
        </p:nvSpPr>
        <p:spPr>
          <a:xfrm>
            <a:off x="6300860" y="931102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Unrelated project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FABC295B-F80A-49AF-AC5B-48453D32B6DF}"/>
              </a:ext>
            </a:extLst>
          </p:cNvPr>
          <p:cNvSpPr txBox="1"/>
          <p:nvPr/>
        </p:nvSpPr>
        <p:spPr>
          <a:xfrm>
            <a:off x="6300860" y="5716487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Unrelated project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9F3F173-3D2D-4784-BB94-DF45A8744CE9}"/>
              </a:ext>
            </a:extLst>
          </p:cNvPr>
          <p:cNvSpPr txBox="1"/>
          <p:nvPr/>
        </p:nvSpPr>
        <p:spPr>
          <a:xfrm>
            <a:off x="4951003" y="5716487"/>
            <a:ext cx="1107347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CA" sz="1200" dirty="0"/>
              <a:t>Middle-aged </a:t>
            </a:r>
          </a:p>
          <a:p>
            <a:pPr algn="ctr"/>
            <a:r>
              <a:rPr lang="en-CA" sz="1200" dirty="0"/>
              <a:t> female</a:t>
            </a:r>
          </a:p>
        </p:txBody>
      </p:sp>
    </p:spTree>
    <p:extLst>
      <p:ext uri="{BB962C8B-B14F-4D97-AF65-F5344CB8AC3E}">
        <p14:creationId xmlns:p14="http://schemas.microsoft.com/office/powerpoint/2010/main" val="26644678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3</TotalTime>
  <Words>64</Words>
  <Application>Microsoft Office PowerPoint</Application>
  <PresentationFormat>Widescreen</PresentationFormat>
  <Paragraphs>27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 Howlett</dc:creator>
  <cp:lastModifiedBy>Susan Howlett</cp:lastModifiedBy>
  <cp:revision>4</cp:revision>
  <dcterms:created xsi:type="dcterms:W3CDTF">2019-10-31T18:03:46Z</dcterms:created>
  <dcterms:modified xsi:type="dcterms:W3CDTF">2019-10-31T18:36:51Z</dcterms:modified>
</cp:coreProperties>
</file>